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8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30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中本 五鈴" userId="f8843875-9782-460f-87aa-ebe252820cc0" providerId="ADAL" clId="{C10A80BD-F904-437A-85C5-86A88845BDA5}"/>
    <pc:docChg chg="modSld">
      <pc:chgData name="中本 五鈴" userId="f8843875-9782-460f-87aa-ebe252820cc0" providerId="ADAL" clId="{C10A80BD-F904-437A-85C5-86A88845BDA5}" dt="2026-02-02T02:17:02.657" v="0" actId="14100"/>
      <pc:docMkLst>
        <pc:docMk/>
      </pc:docMkLst>
      <pc:sldChg chg="modSp mod">
        <pc:chgData name="中本 五鈴" userId="f8843875-9782-460f-87aa-ebe252820cc0" providerId="ADAL" clId="{C10A80BD-F904-437A-85C5-86A88845BDA5}" dt="2026-02-02T02:17:02.657" v="0" actId="14100"/>
        <pc:sldMkLst>
          <pc:docMk/>
          <pc:sldMk cId="2997946699" sldId="258"/>
        </pc:sldMkLst>
        <pc:spChg chg="mod">
          <ac:chgData name="中本 五鈴" userId="f8843875-9782-460f-87aa-ebe252820cc0" providerId="ADAL" clId="{C10A80BD-F904-437A-85C5-86A88845BDA5}" dt="2026-02-02T02:17:02.657" v="0" actId="14100"/>
          <ac:spMkLst>
            <pc:docMk/>
            <pc:sldMk cId="2997946699" sldId="258"/>
            <ac:spMk id="3" creationId="{7C863E8A-7EE0-B9D9-EF12-02CD0F596502}"/>
          </ac:spMkLst>
        </pc:spChg>
      </pc:sldChg>
    </pc:docChg>
  </pc:docChgLst>
  <pc:docChgLst>
    <pc:chgData name="中本 五鈴" userId="f8843875-9782-460f-87aa-ebe252820cc0" providerId="ADAL" clId="{26EC5B4A-E9D0-47B9-8DD5-E4FEB01B0699}"/>
    <pc:docChg chg="undo custSel modSld modMainMaster">
      <pc:chgData name="中本 五鈴" userId="f8843875-9782-460f-87aa-ebe252820cc0" providerId="ADAL" clId="{26EC5B4A-E9D0-47B9-8DD5-E4FEB01B0699}" dt="2026-01-25T10:54:48.904" v="184" actId="1076"/>
      <pc:docMkLst>
        <pc:docMk/>
      </pc:docMkLst>
      <pc:sldChg chg="addSp delSp modSp mod">
        <pc:chgData name="中本 五鈴" userId="f8843875-9782-460f-87aa-ebe252820cc0" providerId="ADAL" clId="{26EC5B4A-E9D0-47B9-8DD5-E4FEB01B0699}" dt="2026-01-25T10:54:48.904" v="184" actId="1076"/>
        <pc:sldMkLst>
          <pc:docMk/>
          <pc:sldMk cId="2997946699" sldId="258"/>
        </pc:sldMkLst>
        <pc:spChg chg="add mod">
          <ac:chgData name="中本 五鈴" userId="f8843875-9782-460f-87aa-ebe252820cc0" providerId="ADAL" clId="{26EC5B4A-E9D0-47B9-8DD5-E4FEB01B0699}" dt="2026-01-25T10:54:29.633" v="181"/>
          <ac:spMkLst>
            <pc:docMk/>
            <pc:sldMk cId="2997946699" sldId="258"/>
            <ac:spMk id="3" creationId="{7C863E8A-7EE0-B9D9-EF12-02CD0F596502}"/>
          </ac:spMkLst>
        </pc:spChg>
        <pc:grpChg chg="add mod">
          <ac:chgData name="中本 五鈴" userId="f8843875-9782-460f-87aa-ebe252820cc0" providerId="ADAL" clId="{26EC5B4A-E9D0-47B9-8DD5-E4FEB01B0699}" dt="2026-01-25T10:54:48.904" v="184" actId="1076"/>
          <ac:grpSpMkLst>
            <pc:docMk/>
            <pc:sldMk cId="2997946699" sldId="258"/>
            <ac:grpSpMk id="9" creationId="{53771FFE-DB87-E37D-FD3B-9E2327498DF1}"/>
          </ac:grpSpMkLst>
        </pc:grpChg>
        <pc:picChg chg="add mod">
          <ac:chgData name="中本 五鈴" userId="f8843875-9782-460f-87aa-ebe252820cc0" providerId="ADAL" clId="{26EC5B4A-E9D0-47B9-8DD5-E4FEB01B0699}" dt="2026-01-25T10:54:29.633" v="181"/>
          <ac:picMkLst>
            <pc:docMk/>
            <pc:sldMk cId="2997946699" sldId="258"/>
            <ac:picMk id="4" creationId="{3CAA7EDA-D1CA-F2CD-C271-8B3589E10BC9}"/>
          </ac:picMkLst>
        </pc:picChg>
        <pc:picChg chg="add mod">
          <ac:chgData name="中本 五鈴" userId="f8843875-9782-460f-87aa-ebe252820cc0" providerId="ADAL" clId="{26EC5B4A-E9D0-47B9-8DD5-E4FEB01B0699}" dt="2026-01-25T10:54:29.633" v="181"/>
          <ac:picMkLst>
            <pc:docMk/>
            <pc:sldMk cId="2997946699" sldId="258"/>
            <ac:picMk id="5" creationId="{B2EDC3D2-36C5-01BE-92E1-5221317C7BF1}"/>
          </ac:picMkLst>
        </pc:picChg>
        <pc:picChg chg="add mod">
          <ac:chgData name="中本 五鈴" userId="f8843875-9782-460f-87aa-ebe252820cc0" providerId="ADAL" clId="{26EC5B4A-E9D0-47B9-8DD5-E4FEB01B0699}" dt="2026-01-25T10:54:29.633" v="181"/>
          <ac:picMkLst>
            <pc:docMk/>
            <pc:sldMk cId="2997946699" sldId="258"/>
            <ac:picMk id="6" creationId="{9E9C6121-855B-C508-F8C1-84933E462A07}"/>
          </ac:picMkLst>
        </pc:picChg>
        <pc:picChg chg="add mod">
          <ac:chgData name="中本 五鈴" userId="f8843875-9782-460f-87aa-ebe252820cc0" providerId="ADAL" clId="{26EC5B4A-E9D0-47B9-8DD5-E4FEB01B0699}" dt="2026-01-25T10:54:29.633" v="181"/>
          <ac:picMkLst>
            <pc:docMk/>
            <pc:sldMk cId="2997946699" sldId="258"/>
            <ac:picMk id="8" creationId="{68E6319B-6FCA-A8D7-7C74-B8C2D88E08F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03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256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891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9596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3477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1244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926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647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075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7966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528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1C488B-4F64-4E72-BFD4-C635E30C0EB6}" type="datetimeFigureOut">
              <a:rPr kumimoji="1" lang="ja-JP" altLang="en-US" smtClean="0"/>
              <a:t>2026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4877A6-B348-44AD-B409-1FB2BB958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147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111670-78C4-EA11-61F7-82DB9C5820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53771FFE-DB87-E37D-FD3B-9E2327498DF1}"/>
              </a:ext>
            </a:extLst>
          </p:cNvPr>
          <p:cNvGrpSpPr/>
          <p:nvPr/>
        </p:nvGrpSpPr>
        <p:grpSpPr>
          <a:xfrm>
            <a:off x="369514" y="568647"/>
            <a:ext cx="8404972" cy="5866363"/>
            <a:chOff x="561135" y="603540"/>
            <a:chExt cx="8404972" cy="5866363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7C863E8A-7EE0-B9D9-EF12-02CD0F596502}"/>
                </a:ext>
              </a:extLst>
            </p:cNvPr>
            <p:cNvSpPr txBox="1"/>
            <p:nvPr/>
          </p:nvSpPr>
          <p:spPr>
            <a:xfrm>
              <a:off x="561135" y="6039016"/>
              <a:ext cx="766806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upplementary figure1. </a:t>
              </a:r>
              <a:r>
                <a:rPr lang="en-US" altLang="ja-JP" sz="11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Distribution of the light exposure.</a:t>
              </a:r>
            </a:p>
            <a:p>
              <a:r>
                <a:rPr lang="en-US" altLang="ja-JP" sz="105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ML, morning light; EL, evening light.</a:t>
              </a:r>
              <a:endParaRPr lang="ja-JP" altLang="en-US" sz="105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CAA7EDA-D1CA-F2CD-C271-8B3589E10B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1135" y="661479"/>
              <a:ext cx="4238625" cy="262890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B2EDC3D2-36C5-01BE-92E1-5221317C7BF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99760" y="603540"/>
              <a:ext cx="4124325" cy="2638425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9E9C6121-855B-C508-F8C1-84933E462A0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1135" y="3241965"/>
              <a:ext cx="4133850" cy="2657475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68E6319B-6FCA-A8D7-7C74-B8C2D88E08F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813207" y="3238498"/>
              <a:ext cx="4152900" cy="2667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97946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</TotalTime>
  <Words>19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中本 五鈴</dc:creator>
  <cp:lastModifiedBy>中本 五鈴</cp:lastModifiedBy>
  <cp:revision>1</cp:revision>
  <cp:lastPrinted>2025-11-12T08:18:35Z</cp:lastPrinted>
  <dcterms:created xsi:type="dcterms:W3CDTF">2025-11-12T08:00:32Z</dcterms:created>
  <dcterms:modified xsi:type="dcterms:W3CDTF">2026-02-02T02:17:06Z</dcterms:modified>
</cp:coreProperties>
</file>